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BCEE16-A390-4CE3-BAE9-6B2700BAA8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5AA91-C507-4816-BE3F-9E3A4EACB0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97A3E2-BA57-4109-8BC2-A22533B2E1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C94BF-082B-4B63-B1ED-396D172D2B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1DF114-69E8-4858-A293-B961CE1F87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2A257-E642-41F8-BCC1-DE92A7F8D8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DA9A6-49D0-4DF2-909E-3FC551E55F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AE2FF-6511-490F-A855-A5DEF0391E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07802-AAE7-4EE2-BBC0-31B157BDB0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10BEF-D60A-4663-8C18-88AAB8232B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1127A-D564-48FB-85A6-6F7F2D0EE9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4CF54-3CCC-47CF-8AFD-90ADBA21AB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F829F6-9AD9-4A48-B390-DF957741A8F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51040" y="1816200"/>
            <a:ext cx="93600" cy="4172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077840" y="1333440"/>
            <a:ext cx="93600" cy="90000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306440" y="1535040"/>
            <a:ext cx="88920" cy="69840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530360" y="1819440"/>
            <a:ext cx="93600" cy="4140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58960" y="1816200"/>
            <a:ext cx="92160" cy="4172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986120" y="1709640"/>
            <a:ext cx="93600" cy="523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214720" y="1812960"/>
            <a:ext cx="88920" cy="42048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438280" y="2044800"/>
            <a:ext cx="93960" cy="1886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665440" y="1816200"/>
            <a:ext cx="93600" cy="4172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894040" y="1736640"/>
            <a:ext cx="93600" cy="496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121200" y="1889280"/>
            <a:ext cx="90360" cy="34416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346560" y="2058840"/>
            <a:ext cx="91800" cy="1746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895320" y="1774440"/>
            <a:ext cx="1440" cy="41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884160" y="177480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1123920" y="1208160"/>
            <a:ext cx="1440" cy="125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112760" y="120816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1351080" y="1442880"/>
            <a:ext cx="1440" cy="92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339920" y="144288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1574640" y="1758960"/>
            <a:ext cx="1800" cy="60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563840" y="175896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1803240" y="1780920"/>
            <a:ext cx="1800" cy="34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92440" y="1781280"/>
            <a:ext cx="25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2030400" y="1592280"/>
            <a:ext cx="1440" cy="117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019240" y="159228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2259000" y="1755360"/>
            <a:ext cx="1440" cy="57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247840" y="1755720"/>
            <a:ext cx="25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V="1">
            <a:off x="2482920" y="2001600"/>
            <a:ext cx="1440" cy="4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471760" y="2001960"/>
            <a:ext cx="25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V="1">
            <a:off x="2711520" y="1778040"/>
            <a:ext cx="144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698920" y="1778040"/>
            <a:ext cx="26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2938320" y="1636560"/>
            <a:ext cx="1800" cy="100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927520" y="1636560"/>
            <a:ext cx="25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3166920" y="1769760"/>
            <a:ext cx="1800" cy="119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156120" y="1770120"/>
            <a:ext cx="25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3390840" y="2001960"/>
            <a:ext cx="1800" cy="56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379680" y="200196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82640" y="979560"/>
            <a:ext cx="1440" cy="1253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765000" y="2233440"/>
            <a:ext cx="176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65000" y="202572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765000" y="181620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765000" y="160668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765000" y="139860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765000" y="118908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765000" y="97956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782640" y="2233440"/>
            <a:ext cx="27241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78264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101124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123984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146376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1690560" y="223308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1919160" y="223308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V="1">
            <a:off x="214632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237024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259884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2825640" y="223308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3054240" y="223308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327816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3506760" y="223308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659880" y="21398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83920" y="19321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07600" y="172260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07600" y="151272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07600" y="130320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07600" y="109548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07600" y="88596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rot="16200000">
            <a:off x="-680400" y="1544400"/>
            <a:ext cx="20581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Percentage of p-PKC activ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771480" y="2205000"/>
            <a:ext cx="280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    2    3    4    1    2    3    4    1    2    3   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811080" y="243684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724040" y="243684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658960" y="243684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907920" y="2381400"/>
            <a:ext cx="6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4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819440" y="23814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732040" y="23814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79280" y="5241960"/>
            <a:ext cx="302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) DMSO; 2) EGF; 3) Enz + EGF; 4) Enz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381560" y="1979640"/>
            <a:ext cx="90360" cy="2509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4605480" y="1701720"/>
            <a:ext cx="93600" cy="52884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834080" y="2119320"/>
            <a:ext cx="88920" cy="11124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5057640" y="2081160"/>
            <a:ext cx="93960" cy="1494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5286240" y="1979640"/>
            <a:ext cx="88920" cy="2509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510160" y="1211400"/>
            <a:ext cx="93600" cy="101916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5737320" y="1500120"/>
            <a:ext cx="90360" cy="73044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5961240" y="1922400"/>
            <a:ext cx="90360" cy="3081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186600" y="1979640"/>
            <a:ext cx="91800" cy="2509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413400" y="1162080"/>
            <a:ext cx="90720" cy="106848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6637320" y="1401840"/>
            <a:ext cx="93600" cy="82872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6865920" y="1895400"/>
            <a:ext cx="88920" cy="3351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4425840" y="1933560"/>
            <a:ext cx="1800" cy="46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414680" y="193356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4651200" y="1647720"/>
            <a:ext cx="1800" cy="54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640400" y="1647720"/>
            <a:ext cx="25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4878360" y="2031480"/>
            <a:ext cx="1440" cy="87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867200" y="203184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5102280" y="2050920"/>
            <a:ext cx="1440" cy="30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5091120" y="205092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5330880" y="1941480"/>
            <a:ext cx="144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5319720" y="1941480"/>
            <a:ext cx="25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flipV="1">
            <a:off x="5554800" y="1131480"/>
            <a:ext cx="1440" cy="79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5543640" y="1131840"/>
            <a:ext cx="25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flipV="1">
            <a:off x="5783400" y="1405080"/>
            <a:ext cx="1440" cy="95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5770440" y="140508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V="1">
            <a:off x="6006960" y="1819440"/>
            <a:ext cx="1800" cy="102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5996160" y="1819440"/>
            <a:ext cx="25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6230880" y="1944360"/>
            <a:ext cx="1800" cy="34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6219720" y="194472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6458040" y="1093680"/>
            <a:ext cx="1440" cy="68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6446880" y="109368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flipV="1">
            <a:off x="6683400" y="1279440"/>
            <a:ext cx="1440" cy="122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6672240" y="1279440"/>
            <a:ext cx="25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flipV="1">
            <a:off x="6910560" y="1834920"/>
            <a:ext cx="1440" cy="60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6899400" y="183528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314960" y="976320"/>
            <a:ext cx="1440" cy="1254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295880" y="223056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295880" y="210492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295880" y="197964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295880" y="185436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295880" y="172872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295880" y="160344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295880" y="147780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4295880" y="135252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295880" y="122724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295880" y="110160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4295880" y="97632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4314960" y="2230560"/>
            <a:ext cx="2708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V="1">
            <a:off x="431496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V="1">
            <a:off x="4538520" y="223020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flipV="1">
            <a:off x="4767120" y="223020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4991040" y="223020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flipV="1">
            <a:off x="521820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V="1">
            <a:off x="544212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 flipV="1">
            <a:off x="567072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V="1">
            <a:off x="5894280" y="223020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flipV="1">
            <a:off x="611820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V="1">
            <a:off x="634680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flipV="1">
            <a:off x="657072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flipV="1">
            <a:off x="679932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flipV="1">
            <a:off x="7023240" y="22302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4182840" y="213660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030200" y="188604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030200" y="163512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030200" y="138420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4030200" y="113364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4030200" y="88092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rot="16200000">
            <a:off x="2826720" y="1431000"/>
            <a:ext cx="20671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Percentage of p-AKT activ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284720" y="2181240"/>
            <a:ext cx="280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    2    3    4    1    2    3    4    1    2    3   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324320" y="241308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5237280" y="241308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6172200" y="241308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4421160" y="235728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4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332320" y="235728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6245280" y="235728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826920" y="4025880"/>
            <a:ext cx="90720" cy="5018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050840" y="3565440"/>
            <a:ext cx="93600" cy="96228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279440" y="4037040"/>
            <a:ext cx="88920" cy="49068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1503360" y="3998880"/>
            <a:ext cx="93600" cy="5288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1731960" y="4025880"/>
            <a:ext cx="88920" cy="5018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1955880" y="3851280"/>
            <a:ext cx="93600" cy="67644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182680" y="3900600"/>
            <a:ext cx="90720" cy="62712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406600" y="4260960"/>
            <a:ext cx="90360" cy="2667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631960" y="4025880"/>
            <a:ext cx="92160" cy="5018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859120" y="3903840"/>
            <a:ext cx="90360" cy="62388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3083040" y="4002120"/>
            <a:ext cx="93600" cy="52560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311640" y="4059360"/>
            <a:ext cx="88920" cy="4683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V="1">
            <a:off x="871560" y="3925800"/>
            <a:ext cx="1440" cy="100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860400" y="392580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 flipV="1">
            <a:off x="1096920" y="3443040"/>
            <a:ext cx="1800" cy="122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1085760" y="344340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V="1">
            <a:off x="1324080" y="3895200"/>
            <a:ext cx="1440" cy="141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1312920" y="389556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1547640" y="3843360"/>
            <a:ext cx="1800" cy="155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1536840" y="384336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V="1">
            <a:off x="1776240" y="3976200"/>
            <a:ext cx="1800" cy="493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1765440" y="3976560"/>
            <a:ext cx="25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flipV="1">
            <a:off x="2000160" y="3679920"/>
            <a:ext cx="1800" cy="171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989000" y="367992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 flipV="1">
            <a:off x="2228760" y="3796920"/>
            <a:ext cx="1800" cy="1033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216160" y="379728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2452680" y="4227120"/>
            <a:ext cx="1440" cy="33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2441520" y="4227480"/>
            <a:ext cx="25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 flipV="1">
            <a:off x="2676600" y="3960360"/>
            <a:ext cx="1440" cy="65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665440" y="3960720"/>
            <a:ext cx="25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 flipV="1">
            <a:off x="2903400" y="3763440"/>
            <a:ext cx="1800" cy="140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2892600" y="3763800"/>
            <a:ext cx="26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 flipV="1">
            <a:off x="3129120" y="3968280"/>
            <a:ext cx="1440" cy="33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117960" y="3968640"/>
            <a:ext cx="25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flipV="1">
            <a:off x="3355920" y="3987360"/>
            <a:ext cx="1800" cy="71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344760" y="398772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760320" y="3273480"/>
            <a:ext cx="1800" cy="1254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741240" y="452772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741240" y="427680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741240" y="40258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741240" y="377496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741240" y="352440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741240" y="32734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760320" y="4527720"/>
            <a:ext cx="2708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 flipV="1">
            <a:off x="76032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 flipV="1">
            <a:off x="98424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 flipV="1">
            <a:off x="121284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 flipV="1">
            <a:off x="143676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 flipV="1">
            <a:off x="166356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 flipV="1">
            <a:off x="188748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flipV="1">
            <a:off x="211608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 flipV="1">
            <a:off x="234000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 flipV="1">
            <a:off x="256392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flipV="1">
            <a:off x="279252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 flipV="1">
            <a:off x="301608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 flipV="1">
            <a:off x="324468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flipV="1">
            <a:off x="346860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637920" y="44258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561600" y="417528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485280" y="392436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485280" y="367344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485280" y="342252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485280" y="317016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rot="16200000">
            <a:off x="-705960" y="3998880"/>
            <a:ext cx="208404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Percentage of p-42/44 activ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717480" y="4489560"/>
            <a:ext cx="280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    2    3    4    1    2    3    4    1    2    3   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757080" y="472140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1670040" y="472140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2604960" y="472140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853920" y="4665600"/>
            <a:ext cx="6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4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1765440" y="46656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2678040" y="46656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4327560" y="3832200"/>
            <a:ext cx="90360" cy="6955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4551480" y="3573360"/>
            <a:ext cx="93600" cy="95436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4780080" y="4105440"/>
            <a:ext cx="88920" cy="42228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5003640" y="4102200"/>
            <a:ext cx="93960" cy="4255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5232240" y="3832200"/>
            <a:ext cx="88920" cy="6955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5456160" y="3710160"/>
            <a:ext cx="93600" cy="81756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5683320" y="3857760"/>
            <a:ext cx="90360" cy="66996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5907240" y="4146480"/>
            <a:ext cx="90360" cy="381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6132600" y="3832200"/>
            <a:ext cx="92160" cy="6955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6359400" y="3672000"/>
            <a:ext cx="90720" cy="855720"/>
          </a:xfrm>
          <a:prstGeom prst="rect">
            <a:avLst/>
          </a:prstGeom>
          <a:solidFill>
            <a:srgbClr val="eaeaea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6583320" y="3941640"/>
            <a:ext cx="93600" cy="586080"/>
          </a:xfrm>
          <a:prstGeom prst="rect">
            <a:avLst/>
          </a:prstGeom>
          <a:solidFill>
            <a:srgbClr val="8080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6811920" y="4127400"/>
            <a:ext cx="88920" cy="400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flipV="1">
            <a:off x="4371840" y="3671640"/>
            <a:ext cx="1800" cy="1602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4361040" y="3672000"/>
            <a:ext cx="26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 flipV="1">
            <a:off x="4597560" y="3371760"/>
            <a:ext cx="1440" cy="201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4586400" y="3371760"/>
            <a:ext cx="25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 flipV="1">
            <a:off x="4824360" y="3854160"/>
            <a:ext cx="1800" cy="250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4813200" y="385452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 flipV="1">
            <a:off x="5048280" y="4017960"/>
            <a:ext cx="1440" cy="84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5037120" y="401796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 flipV="1">
            <a:off x="5276880" y="3712680"/>
            <a:ext cx="1440" cy="119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5265720" y="3713040"/>
            <a:ext cx="25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 flipV="1">
            <a:off x="5500800" y="3516480"/>
            <a:ext cx="1440" cy="193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5489640" y="3516480"/>
            <a:ext cx="25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 flipV="1">
            <a:off x="5729400" y="3767040"/>
            <a:ext cx="1440" cy="90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5716440" y="376704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 flipV="1">
            <a:off x="5952960" y="4063680"/>
            <a:ext cx="1800" cy="82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5942160" y="4064040"/>
            <a:ext cx="25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flipV="1">
            <a:off x="6176880" y="3671640"/>
            <a:ext cx="1800" cy="1602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6165720" y="367200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V="1">
            <a:off x="6404040" y="3409920"/>
            <a:ext cx="1440" cy="262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6392880" y="340992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 flipV="1">
            <a:off x="6629400" y="3796920"/>
            <a:ext cx="1440" cy="144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6618240" y="379728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 flipV="1">
            <a:off x="6856560" y="4028760"/>
            <a:ext cx="1440" cy="98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6845400" y="402912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4260960" y="3273480"/>
            <a:ext cx="1440" cy="1254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4241880" y="452772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4241880" y="438624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4241880" y="424980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4241880" y="410832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4241880" y="396864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4241880" y="383220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4241880" y="36910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4241880" y="354960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241880" y="341316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4241880" y="32734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4260960" y="4527720"/>
            <a:ext cx="2708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 flipV="1">
            <a:off x="426096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 flipV="1">
            <a:off x="448452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 flipV="1">
            <a:off x="471312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V="1">
            <a:off x="493704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 flipV="1">
            <a:off x="516420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 flipV="1">
            <a:off x="538812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 flipV="1">
            <a:off x="561672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 flipV="1">
            <a:off x="584028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flipV="1">
            <a:off x="606420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V="1">
            <a:off x="6292800" y="4527720"/>
            <a:ext cx="180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V="1">
            <a:off x="651672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V="1">
            <a:off x="674532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 flipV="1">
            <a:off x="6969240" y="4527720"/>
            <a:ext cx="1440" cy="18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4144680" y="44416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4068360" y="41641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4068360" y="388296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992040" y="360504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3992040" y="332748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rot="16200000">
            <a:off x="2737440" y="3980880"/>
            <a:ext cx="22957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Percentage of GSK3Beta activ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4233960" y="4491000"/>
            <a:ext cx="280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    2    3    4    1    2    3    4    1    2    3   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4273560" y="472284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5186520" y="4722840"/>
            <a:ext cx="86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6121440" y="472284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4370400" y="46674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4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5281560" y="46674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6194520" y="46674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feld 4"/>
          <p:cNvSpPr/>
          <p:nvPr/>
        </p:nvSpPr>
        <p:spPr>
          <a:xfrm>
            <a:off x="31680" y="30240"/>
            <a:ext cx="207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55440" y="2700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3551400" y="2700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50760" y="27082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546360" y="27082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9T12:43:40Z</dcterms:created>
  <dc:creator>mudduluru</dc:creator>
  <dc:description/>
  <dc:language>en-US</dc:language>
  <cp:lastModifiedBy>mudduluru</cp:lastModifiedBy>
  <dcterms:modified xsi:type="dcterms:W3CDTF">2010-05-03T06:16:55Z</dcterms:modified>
  <cp:revision>6</cp:revision>
  <dc:subject/>
  <dc:title>Folie 1</dc:title>
</cp:coreProperties>
</file>